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2010" y="39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5003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0434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020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506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36179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1545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62373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3287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8067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351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6043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1644A-8969-48BA-8685-6C1DC8132B7E}" type="datetimeFigureOut">
              <a:rPr lang="en-GB" smtClean="0"/>
              <a:t>30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3D9DA-F252-4669-9EB7-C9391A84BB8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0278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900D66C-2FE8-B586-EEB9-691581ED71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4513" y="1666268"/>
            <a:ext cx="1202400" cy="12024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978CBAE-C7A9-C8EF-C7E7-2BB41ECC5BB3}"/>
              </a:ext>
            </a:extLst>
          </p:cNvPr>
          <p:cNvSpPr txBox="1"/>
          <p:nvPr/>
        </p:nvSpPr>
        <p:spPr>
          <a:xfrm>
            <a:off x="3176729" y="1389269"/>
            <a:ext cx="509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PAF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3AEB1D-7121-81DB-CED7-8A5FADC7FE0A}"/>
              </a:ext>
            </a:extLst>
          </p:cNvPr>
          <p:cNvSpPr txBox="1"/>
          <p:nvPr/>
        </p:nvSpPr>
        <p:spPr>
          <a:xfrm>
            <a:off x="1682358" y="1394879"/>
            <a:ext cx="566502" cy="2259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63BAC5-1A0E-68B5-D172-5D8DA2C512A4}"/>
              </a:ext>
            </a:extLst>
          </p:cNvPr>
          <p:cNvSpPr txBox="1"/>
          <p:nvPr/>
        </p:nvSpPr>
        <p:spPr>
          <a:xfrm>
            <a:off x="3846782" y="1223443"/>
            <a:ext cx="20776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200 nmol/L BML-111 </a:t>
            </a:r>
          </a:p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+ 300 nmol/L JNJ + PA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F241BC13-4148-7A56-BEC8-D6637D1E786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8494" y="1666268"/>
            <a:ext cx="1202400" cy="12024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6A1FB3A2-A932-CB20-994D-06BEA14B58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2475" y="2922686"/>
            <a:ext cx="1202400" cy="12024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66BAFC7-8FD7-CF22-885B-59E1595265F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02475" y="1666268"/>
            <a:ext cx="1202400" cy="120240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BC659214-559E-1319-6C42-629C55E8220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2128" y="4486473"/>
            <a:ext cx="1202400" cy="12024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6A69CB5-7E69-D6DF-B0CB-D227C8275FD2}"/>
              </a:ext>
            </a:extLst>
          </p:cNvPr>
          <p:cNvSpPr txBox="1"/>
          <p:nvPr/>
        </p:nvSpPr>
        <p:spPr>
          <a:xfrm rot="16200000">
            <a:off x="995981" y="2063335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O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C62ED36-88EC-E2A0-4532-F05D15E19467}"/>
              </a:ext>
            </a:extLst>
          </p:cNvPr>
          <p:cNvSpPr txBox="1"/>
          <p:nvPr/>
        </p:nvSpPr>
        <p:spPr>
          <a:xfrm rot="16200000">
            <a:off x="997053" y="3339163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EAF144C-66DF-EA0B-A6C3-414FA0BDF470}"/>
              </a:ext>
            </a:extLst>
          </p:cNvPr>
          <p:cNvSpPr txBox="1"/>
          <p:nvPr/>
        </p:nvSpPr>
        <p:spPr>
          <a:xfrm rot="16200000">
            <a:off x="798469" y="4958929"/>
            <a:ext cx="9989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udin-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8D6E3EB-9711-5DB5-70ED-6335DF29A9CB}"/>
              </a:ext>
            </a:extLst>
          </p:cNvPr>
          <p:cNvSpPr txBox="1"/>
          <p:nvPr/>
        </p:nvSpPr>
        <p:spPr>
          <a:xfrm rot="16200000">
            <a:off x="1011667" y="6197179"/>
            <a:ext cx="5725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err="1">
                <a:solidFill>
                  <a:srgbClr val="33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en-GB" sz="1400" b="1">
              <a:solidFill>
                <a:srgbClr val="3333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7274D11-7F50-1590-A0D1-ACBF6188AE62}"/>
              </a:ext>
            </a:extLst>
          </p:cNvPr>
          <p:cNvSpPr txBox="1"/>
          <p:nvPr/>
        </p:nvSpPr>
        <p:spPr>
          <a:xfrm>
            <a:off x="368300" y="330200"/>
            <a:ext cx="2104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 5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B47B8C84-7A70-5C5A-E63B-66FB102C6D2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3945" y="4486473"/>
            <a:ext cx="1202400" cy="120240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7EBB3E08-C935-37FA-58AD-200EBBC070E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6100" y="4486473"/>
            <a:ext cx="1202400" cy="1202400"/>
          </a:xfrm>
          <a:prstGeom prst="rect">
            <a:avLst/>
          </a:prstGeom>
        </p:spPr>
      </p:pic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6B0938F-5DC2-84C5-8C3D-AFA169FBB6F5}"/>
              </a:ext>
            </a:extLst>
          </p:cNvPr>
          <p:cNvCxnSpPr>
            <a:cxnSpLocks/>
          </p:cNvCxnSpPr>
          <p:nvPr/>
        </p:nvCxnSpPr>
        <p:spPr>
          <a:xfrm>
            <a:off x="2411553" y="2742422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0C7FE3EB-5828-AA01-7DEE-BF5E1A4F3523}"/>
              </a:ext>
            </a:extLst>
          </p:cNvPr>
          <p:cNvCxnSpPr>
            <a:cxnSpLocks/>
          </p:cNvCxnSpPr>
          <p:nvPr/>
        </p:nvCxnSpPr>
        <p:spPr>
          <a:xfrm>
            <a:off x="2423280" y="5587787"/>
            <a:ext cx="11475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:a16="http://schemas.microsoft.com/office/drawing/2014/main" id="{79F381EB-E102-EA55-2308-1ED6A399DE4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0543" y="2914140"/>
            <a:ext cx="1202400" cy="1202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E10C151-1EA9-4F02-3DEF-A06D4BC36BBE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8494" y="2914140"/>
            <a:ext cx="1202400" cy="12024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9483292-FC11-FA4E-2F66-EA333BB237E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2126" y="5734345"/>
            <a:ext cx="1202400" cy="120240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6F53559A-685F-D7EF-6ABD-923B78E3FDE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8494" y="5734345"/>
            <a:ext cx="1202400" cy="12024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D8A78954-798B-4AB6-1720-A6AB7F9B5842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004" y="5734345"/>
            <a:ext cx="1202400" cy="12024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34FA8C0-9FE8-9C78-D160-77153BAC289E}"/>
              </a:ext>
            </a:extLst>
          </p:cNvPr>
          <p:cNvSpPr txBox="1"/>
          <p:nvPr/>
        </p:nvSpPr>
        <p:spPr>
          <a:xfrm>
            <a:off x="793172" y="7322127"/>
            <a:ext cx="5496790" cy="10618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GB" sz="1050" b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Figure S5. JNJ26993135 + BML-111 restores PAF-reduced ZO-1 and claudin-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1</a:t>
            </a:r>
            <a:r>
              <a:rPr lang="en-GB" sz="1050" b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at the tight junctions.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  Images of H441 cells treated with </a:t>
            </a:r>
            <a:r>
              <a:rPr lang="en-GB" sz="1050" i="1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Pseudomonas aeruginosa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filtrate (PAF) or PAF + 200 nmol/L BLM-111 and 300 nmol/L JNJ26993135 and 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immunostained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for ZO-1 or Claudin-1 (red) with corresponding images of nuclei stained with 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Dapi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 (blue). All images were obtained at ×63 magnification. Scale bars (20 </a:t>
            </a:r>
            <a:r>
              <a:rPr lang="en-GB" sz="1050" dirty="0" err="1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μm</a:t>
            </a:r>
            <a:r>
              <a:rPr lang="en-GB" sz="1050" dirty="0">
                <a:latin typeface="Arial" panose="020B0604020202020204" pitchFamily="34" charset="0"/>
                <a:ea typeface="+mn-lt"/>
                <a:cs typeface="Arial" panose="020B0604020202020204" pitchFamily="34" charset="0"/>
              </a:rPr>
              <a:t>) are shown on control images only but are applicable to all.</a:t>
            </a:r>
            <a:endParaRPr lang="en-US" sz="1050" dirty="0">
              <a:latin typeface="Arial" panose="020B0604020202020204" pitchFamily="34" charset="0"/>
              <a:ea typeface="+mn-lt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3976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11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eljit Kalsi</dc:creator>
  <cp:lastModifiedBy>Kameljit Kalsi</cp:lastModifiedBy>
  <cp:revision>2</cp:revision>
  <dcterms:created xsi:type="dcterms:W3CDTF">2022-06-02T11:20:02Z</dcterms:created>
  <dcterms:modified xsi:type="dcterms:W3CDTF">2023-03-30T15:27:54Z</dcterms:modified>
</cp:coreProperties>
</file>